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MX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1" autoAdjust="0"/>
    <p:restoredTop sz="94660"/>
  </p:normalViewPr>
  <p:slideViewPr>
    <p:cSldViewPr snapToGrid="0">
      <p:cViewPr varScale="1">
        <p:scale>
          <a:sx n="61" d="100"/>
          <a:sy n="61" d="100"/>
        </p:scale>
        <p:origin x="84" y="7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C8CAF6D-408B-007E-14A1-BE993BDEDA0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B88BECE8-BDFD-12EB-77FD-07B3369E6DC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EA53BB85-B6B0-0A67-97CB-C950A77D01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0DD43-9CBD-404F-B338-6C445CF7B398}" type="datetimeFigureOut">
              <a:rPr lang="es-MX" smtClean="0"/>
              <a:t>06/09/2023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24298F24-E20E-6B2D-6988-3BA2158A55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D0BCA5C-FAF0-89E5-DAEF-F43B1092E7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99CFC2-0B4A-4D0F-9928-1D3960305D1F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2959937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C01473E-D40D-124F-DE53-03940BC61B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59EB370E-BE64-82D9-6A61-93E9FBE7817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76355FB-1513-FEC2-6F7D-65E5159238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0DD43-9CBD-404F-B338-6C445CF7B398}" type="datetimeFigureOut">
              <a:rPr lang="es-MX" smtClean="0"/>
              <a:t>06/09/2023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87102D8-E413-0E13-37FA-CB204E3551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6547CE8-A1F6-43F7-CA95-AC8241D7EF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99CFC2-0B4A-4D0F-9928-1D3960305D1F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9869329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826079DB-AF2F-9380-1C44-56353A00E86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E01CCDF3-4C39-544A-FDB5-B967DDED48B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C0F4A988-4C77-4B4B-245E-7F92E0C84C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0DD43-9CBD-404F-B338-6C445CF7B398}" type="datetimeFigureOut">
              <a:rPr lang="es-MX" smtClean="0"/>
              <a:t>06/09/2023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29D27074-9CE8-D9EF-4390-27C4F66BB5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860EA59F-C91B-8BB6-E231-13D848E4DC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99CFC2-0B4A-4D0F-9928-1D3960305D1F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9241816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D04D456-99F4-0CA7-F6AE-56A5CF2787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FAA52A3E-0C66-93F3-DF1D-00DEE582DD9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0580E35-D5EE-77FE-1311-9047B88152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0DD43-9CBD-404F-B338-6C445CF7B398}" type="datetimeFigureOut">
              <a:rPr lang="es-MX" smtClean="0"/>
              <a:t>06/09/2023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9711BA7-F3BC-0156-BDCE-3869A9916C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78415C48-1FCD-C225-00B8-F11D7305A2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99CFC2-0B4A-4D0F-9928-1D3960305D1F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7168463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74C1CFB-956C-D423-D098-E4A8454892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2A2A4648-26DC-CF6F-D2F5-479413EA49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F214C8D1-35BD-1E92-4374-89FA261F4D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0DD43-9CBD-404F-B338-6C445CF7B398}" type="datetimeFigureOut">
              <a:rPr lang="es-MX" smtClean="0"/>
              <a:t>06/09/2023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B7B8B116-C2FF-307C-6F34-F7F48C3AF5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EC2CF527-FAA8-3902-E398-948F81CE69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99CFC2-0B4A-4D0F-9928-1D3960305D1F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5500889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424500A-551C-8E2B-7C85-DED939F024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2BBE1F81-2F95-0346-CBE8-9748792E44C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A058D029-BECF-79CF-6F49-5C22D943BA1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A512593D-E285-1584-7017-51366F1183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0DD43-9CBD-404F-B338-6C445CF7B398}" type="datetimeFigureOut">
              <a:rPr lang="es-MX" smtClean="0"/>
              <a:t>06/09/2023</a:t>
            </a:fld>
            <a:endParaRPr lang="es-MX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F4161241-E3E8-BE23-F716-3F53E1885C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E5C964C7-E49C-5ED2-5597-3A2EFF34F6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99CFC2-0B4A-4D0F-9928-1D3960305D1F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9822094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713EEE9-0BDE-7C94-2EB1-97F0BF8823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7D304361-0C96-2E45-62B9-A7FD40735F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697E2217-A628-ABDE-89F2-5BE283DB89F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1C2EAF82-F201-EF93-F3B0-DF73C9A23DD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2F51E280-341E-4350-9F90-19F7BE2CE21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6F5DE59A-69AE-F5C8-D22A-2866D33CA3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0DD43-9CBD-404F-B338-6C445CF7B398}" type="datetimeFigureOut">
              <a:rPr lang="es-MX" smtClean="0"/>
              <a:t>06/09/2023</a:t>
            </a:fld>
            <a:endParaRPr lang="es-MX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A6BEC74B-9506-891A-E6D2-8985970437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BBA019B5-683C-4A2F-35F5-6D27411DCE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99CFC2-0B4A-4D0F-9928-1D3960305D1F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9983497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E827EFE-BD82-8421-B591-6521CD463F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32986ACC-A3E1-5980-C70D-566CDFF8A5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0DD43-9CBD-404F-B338-6C445CF7B398}" type="datetimeFigureOut">
              <a:rPr lang="es-MX" smtClean="0"/>
              <a:t>06/09/2023</a:t>
            </a:fld>
            <a:endParaRPr lang="es-MX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342373FA-B30D-8EAE-AD18-3A681E76B9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D5BB9188-A6D5-5C9C-7772-4FC5BA195E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99CFC2-0B4A-4D0F-9928-1D3960305D1F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8744782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7E82E372-79A2-630D-8C78-DD6D0C7738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0DD43-9CBD-404F-B338-6C445CF7B398}" type="datetimeFigureOut">
              <a:rPr lang="es-MX" smtClean="0"/>
              <a:t>06/09/2023</a:t>
            </a:fld>
            <a:endParaRPr lang="es-MX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DCE6D840-3293-2E0B-79D7-78BA4C3DDF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D3B7B70A-6596-61B3-32AF-3D78C8C88F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99CFC2-0B4A-4D0F-9928-1D3960305D1F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6674504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B97504E-1248-5E10-B6E6-28B9FD8420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DCA5A681-CB29-D294-03A5-44F9CD6846B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3D6C23A7-4558-4686-523A-DB382E39E26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CEA509FE-424D-68E9-D282-12E40FD404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0DD43-9CBD-404F-B338-6C445CF7B398}" type="datetimeFigureOut">
              <a:rPr lang="es-MX" smtClean="0"/>
              <a:t>06/09/2023</a:t>
            </a:fld>
            <a:endParaRPr lang="es-MX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E3F4D36A-F077-B850-4ADC-B67F80813D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0C5A5D6D-9007-BB51-13E6-69C5C35FD0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99CFC2-0B4A-4D0F-9928-1D3960305D1F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9720585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5675449-3FAC-4C3A-B539-1AE78CC9E1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A839A1D7-D9F7-08B6-B4AD-70FDD15F721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MX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982D4206-C592-4467-8D64-359FBD94EE0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63C105C7-FAB1-0E78-0744-E14400A53E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0DD43-9CBD-404F-B338-6C445CF7B398}" type="datetimeFigureOut">
              <a:rPr lang="es-MX" smtClean="0"/>
              <a:t>06/09/2023</a:t>
            </a:fld>
            <a:endParaRPr lang="es-MX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805B84A6-9C1B-0094-01AA-4C1A90965B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38B02112-791D-0C46-AA95-6BBEE276A1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99CFC2-0B4A-4D0F-9928-1D3960305D1F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7350438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9AA9B44F-FC0A-FFC9-1300-C870D9EBF1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CB7F0CC5-A663-A758-FE34-E4B78600EE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11503FF5-FBA6-BB17-ECFD-59875FA4859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C0DD43-9CBD-404F-B338-6C445CF7B398}" type="datetimeFigureOut">
              <a:rPr lang="es-MX" smtClean="0"/>
              <a:t>06/09/2023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0926339-CAEB-F042-371A-F1A213DACBA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7BBE367C-1836-523E-B3DE-95C2CE0D45F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99CFC2-0B4A-4D0F-9928-1D3960305D1F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0473579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MX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2">
            <a:extLst>
              <a:ext uri="{FF2B5EF4-FFF2-40B4-BE49-F238E27FC236}">
                <a16:creationId xmlns:a16="http://schemas.microsoft.com/office/drawing/2014/main" id="{F382D823-CAE6-3008-5B54-68145029674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88805580"/>
              </p:ext>
            </p:extLst>
          </p:nvPr>
        </p:nvGraphicFramePr>
        <p:xfrm>
          <a:off x="5840218" y="772105"/>
          <a:ext cx="5949275" cy="36852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4664288" imgH="2779624" progId="Prism8.Document">
                  <p:embed/>
                </p:oleObj>
              </mc:Choice>
              <mc:Fallback>
                <p:oleObj name="Prism 8" r:id="rId2" imgW="4664288" imgH="2779624" progId="Prism8.Document">
                  <p:embed/>
                  <p:pic>
                    <p:nvPicPr>
                      <p:cNvPr id="22530" name="Object 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840218" y="772105"/>
                        <a:ext cx="5949275" cy="3685264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2">
            <a:extLst>
              <a:ext uri="{FF2B5EF4-FFF2-40B4-BE49-F238E27FC236}">
                <a16:creationId xmlns:a16="http://schemas.microsoft.com/office/drawing/2014/main" id="{87498440-2C4A-0B05-056F-6BD0E3BFD08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80913254"/>
              </p:ext>
            </p:extLst>
          </p:nvPr>
        </p:nvGraphicFramePr>
        <p:xfrm>
          <a:off x="829751" y="772105"/>
          <a:ext cx="4376737" cy="33035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3245708" imgH="2448819" progId="Prism8.Document">
                  <p:embed/>
                </p:oleObj>
              </mc:Choice>
              <mc:Fallback>
                <p:oleObj name="Prism 8" r:id="rId4" imgW="3245708" imgH="2448819" progId="Prism8.Document">
                  <p:embed/>
                  <p:pic>
                    <p:nvPicPr>
                      <p:cNvPr id="3" name="Object 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829751" y="772105"/>
                        <a:ext cx="4376737" cy="330358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CuadroTexto 5">
            <a:extLst>
              <a:ext uri="{FF2B5EF4-FFF2-40B4-BE49-F238E27FC236}">
                <a16:creationId xmlns:a16="http://schemas.microsoft.com/office/drawing/2014/main" id="{49DBD5A4-759D-6094-62BB-A4A1C24DF678}"/>
              </a:ext>
            </a:extLst>
          </p:cNvPr>
          <p:cNvSpPr txBox="1"/>
          <p:nvPr/>
        </p:nvSpPr>
        <p:spPr>
          <a:xfrm>
            <a:off x="445258" y="87680"/>
            <a:ext cx="876233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2400" b="1" dirty="0">
                <a:latin typeface="Arial" panose="020B0604020202020204" pitchFamily="34" charset="0"/>
                <a:cs typeface="Arial" panose="020B0604020202020204" pitchFamily="34" charset="0"/>
              </a:rPr>
              <a:t>A                                                         B</a:t>
            </a:r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0BCA0518-F9D9-E759-3A7E-3351198D2B25}"/>
              </a:ext>
            </a:extLst>
          </p:cNvPr>
          <p:cNvSpPr txBox="1"/>
          <p:nvPr/>
        </p:nvSpPr>
        <p:spPr>
          <a:xfrm>
            <a:off x="628138" y="4921288"/>
            <a:ext cx="10936941" cy="18490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dditional 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1. E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ectrocardiographic register (A) and blood pressure measure (B). These measurements were performed by means of surgical procedure. To this, rats were anesthetized with sodium pentobarbital (60 mg/kg </a:t>
            </a:r>
            <a:r>
              <a:rPr lang="en-US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w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and artificially ventilated through a cannula inserted into the trachea. One pressure transducer introduced in the femoral artery and three surface electrodes in DII, both connected to a SIEVART program led us to obtain the data of cardiac frequency (bpm) and blood pressure (mmHg) during a period of 10 minutes.</a:t>
            </a:r>
            <a:endParaRPr lang="es-MX" sz="18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8190388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1</Words>
  <Application>Microsoft Office PowerPoint</Application>
  <PresentationFormat>Panorámica</PresentationFormat>
  <Paragraphs>2</Paragraphs>
  <Slides>1</Slides>
  <Notes>0</Notes>
  <HiddenSlides>0</HiddenSlides>
  <MMClips>0</MMClips>
  <ScaleCrop>false</ScaleCrop>
  <HeadingPairs>
    <vt:vector size="8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ema de Office</vt:lpstr>
      <vt:lpstr>Prism 8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Rebeca López</dc:creator>
  <cp:lastModifiedBy>Rebeca López</cp:lastModifiedBy>
  <cp:revision>2</cp:revision>
  <dcterms:created xsi:type="dcterms:W3CDTF">2023-08-31T22:34:58Z</dcterms:created>
  <dcterms:modified xsi:type="dcterms:W3CDTF">2023-09-06T18:23:00Z</dcterms:modified>
</cp:coreProperties>
</file>